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6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2542D-7C69-4C1B-AD4B-2781E1362EDB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921AD9-7B80-4ADA-B320-1DA05726B9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85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 S4 and table 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DB3FFA-3AD9-4FEB-8A03-5A612FF74AD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54194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913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13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784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882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378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96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8547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082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974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001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242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8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Fig. </a:t>
            </a:r>
            <a:r>
              <a:rPr lang="en-GB" smtClean="0"/>
              <a:t>S4</a:t>
            </a:r>
            <a:endParaRPr lang="en-GB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9" t="6451" r="4154" b="6708"/>
          <a:stretch/>
        </p:blipFill>
        <p:spPr bwMode="auto">
          <a:xfrm>
            <a:off x="446813" y="1556341"/>
            <a:ext cx="5676194" cy="393825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7" t="6495" r="4490" b="6260"/>
          <a:stretch/>
        </p:blipFill>
        <p:spPr bwMode="auto">
          <a:xfrm>
            <a:off x="6178992" y="1556342"/>
            <a:ext cx="5594981" cy="3938254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Rectangle 2"/>
          <p:cNvSpPr/>
          <p:nvPr/>
        </p:nvSpPr>
        <p:spPr>
          <a:xfrm>
            <a:off x="620547" y="5696754"/>
            <a:ext cx="11116890" cy="58785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Fig. S4.  Profile of fatty acids collected in negative mode of Direct Infusion-MS with collision-induced dissociation of samples washed with hexane.  </a:t>
            </a:r>
            <a:r>
              <a:rPr lang="en-GB" sz="1400" i="1" dirty="0" smtClean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Left, </a:t>
            </a:r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more abundant species</a:t>
            </a:r>
            <a:r>
              <a:rPr lang="en-GB" sz="1400" i="1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GB" sz="1400" i="1" smtClean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Right, </a:t>
            </a:r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less abundant species.</a:t>
            </a:r>
            <a:endParaRPr lang="en-GB" sz="1400" dirty="0">
              <a:effectLst/>
              <a:latin typeface="Gentium Basic" panose="02000503060000020004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8600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5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Gentium Basic</vt:lpstr>
      <vt:lpstr>Times New Roman</vt:lpstr>
      <vt:lpstr>Office Theme</vt:lpstr>
      <vt:lpstr>Fig. S4</vt:lpstr>
    </vt:vector>
  </TitlesOfParts>
  <Company>Clinical School Computing Servi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</dc:title>
  <dc:creator>Samuel Furse</dc:creator>
  <cp:lastModifiedBy>Samuel Furse</cp:lastModifiedBy>
  <cp:revision>11</cp:revision>
  <dcterms:created xsi:type="dcterms:W3CDTF">2019-04-10T14:00:46Z</dcterms:created>
  <dcterms:modified xsi:type="dcterms:W3CDTF">2019-04-29T07:48:48Z</dcterms:modified>
</cp:coreProperties>
</file>